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xmlns="" id="{3B82E029-9052-8747-AC27-E09ED15D3A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8822132"/>
              </p:ext>
            </p:extLst>
          </p:nvPr>
        </p:nvGraphicFramePr>
        <p:xfrm>
          <a:off x="955963" y="886692"/>
          <a:ext cx="10640293" cy="44334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30037">
                  <a:extLst>
                    <a:ext uri="{9D8B030D-6E8A-4147-A177-3AD203B41FA5}">
                      <a16:colId xmlns:a16="http://schemas.microsoft.com/office/drawing/2014/main" xmlns="" val="3573761506"/>
                    </a:ext>
                  </a:extLst>
                </a:gridCol>
                <a:gridCol w="1330037">
                  <a:extLst>
                    <a:ext uri="{9D8B030D-6E8A-4147-A177-3AD203B41FA5}">
                      <a16:colId xmlns:a16="http://schemas.microsoft.com/office/drawing/2014/main" xmlns="" val="3965034928"/>
                    </a:ext>
                  </a:extLst>
                </a:gridCol>
                <a:gridCol w="1330037">
                  <a:extLst>
                    <a:ext uri="{9D8B030D-6E8A-4147-A177-3AD203B41FA5}">
                      <a16:colId xmlns:a16="http://schemas.microsoft.com/office/drawing/2014/main" xmlns="" val="3793901268"/>
                    </a:ext>
                  </a:extLst>
                </a:gridCol>
                <a:gridCol w="1330037">
                  <a:extLst>
                    <a:ext uri="{9D8B030D-6E8A-4147-A177-3AD203B41FA5}">
                      <a16:colId xmlns:a16="http://schemas.microsoft.com/office/drawing/2014/main" xmlns="" val="807721954"/>
                    </a:ext>
                  </a:extLst>
                </a:gridCol>
                <a:gridCol w="1330037">
                  <a:extLst>
                    <a:ext uri="{9D8B030D-6E8A-4147-A177-3AD203B41FA5}">
                      <a16:colId xmlns:a16="http://schemas.microsoft.com/office/drawing/2014/main" xmlns="" val="4208604158"/>
                    </a:ext>
                  </a:extLst>
                </a:gridCol>
                <a:gridCol w="1425038">
                  <a:extLst>
                    <a:ext uri="{9D8B030D-6E8A-4147-A177-3AD203B41FA5}">
                      <a16:colId xmlns:a16="http://schemas.microsoft.com/office/drawing/2014/main" xmlns="" val="2661573607"/>
                    </a:ext>
                  </a:extLst>
                </a:gridCol>
                <a:gridCol w="1047140">
                  <a:extLst>
                    <a:ext uri="{9D8B030D-6E8A-4147-A177-3AD203B41FA5}">
                      <a16:colId xmlns:a16="http://schemas.microsoft.com/office/drawing/2014/main" xmlns="" val="3199578645"/>
                    </a:ext>
                  </a:extLst>
                </a:gridCol>
                <a:gridCol w="1517930">
                  <a:extLst>
                    <a:ext uri="{9D8B030D-6E8A-4147-A177-3AD203B41FA5}">
                      <a16:colId xmlns:a16="http://schemas.microsoft.com/office/drawing/2014/main" xmlns="" val="3680117016"/>
                    </a:ext>
                  </a:extLst>
                </a:gridCol>
              </a:tblGrid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Biomarkers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Day 0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Day 3-4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Day 3-4 vs Day 0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1106939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Survivors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Non-survivors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Day 0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Survivors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Non-survivors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Day 0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94887551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Neutrophils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.10</a:t>
                      </a:r>
                      <a:r>
                        <a:rPr lang="en-US" sz="1200" b="1" baseline="300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/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8050 </a:t>
                      </a: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[5575-1056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8845 </a:t>
                      </a: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[7453-12963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3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085 [5210-1190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10960 [8430-11000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14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a, 0.18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b, 0.27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87374257"/>
                  </a:ext>
                </a:extLst>
              </a:tr>
              <a:tr h="47766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Lymphocytes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.10</a:t>
                      </a:r>
                      <a:r>
                        <a:rPr lang="en-US" sz="1200" b="1" baseline="300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/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20 [635-121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25 [435-103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55 [730-170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470 [235-622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a, &lt;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b, 0.2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71784062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CRP 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mg/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90 [80-24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278 [184-302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0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8 [45-18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305 [159-350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a, &lt;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b, 0.7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66587051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Fibrinogen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g/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7.6 [6.6-8.7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.3 [6.9-9.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20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7.3 [6.1-8.7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9.4 [8.0-10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a, 0.1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b, 0.0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64399048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IL-6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pg/m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76 [31-197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03 [72-846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52 [23-11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162 [42-518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a, 0.12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b, 0.27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69423731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TNF-a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chemeClr val="tx1"/>
                          </a:solidFill>
                          <a:effectLst/>
                        </a:rPr>
                        <a:t>(pg/mL)</a:t>
                      </a:r>
                      <a:endParaRPr lang="fr-FR" sz="12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16 [0-27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9 [0-48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14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21 [16-33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27 [0-34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48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a, 0.07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b, 0.29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95769808"/>
                  </a:ext>
                </a:extLst>
              </a:tr>
              <a:tr h="49447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IL-10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(</a:t>
                      </a:r>
                      <a:r>
                        <a:rPr lang="en-US" sz="1200" b="1" dirty="0" err="1">
                          <a:solidFill>
                            <a:schemeClr val="tx1"/>
                          </a:solidFill>
                          <a:effectLst/>
                        </a:rPr>
                        <a:t>pg</a:t>
                      </a: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/mL)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22 [13-36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44 [21-55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2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19 [13-27]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4 [12-44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a, 0.20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b, 0.45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84535410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9C8AEFD3-B0BE-BC49-9E4A-5B606BB72A8B}"/>
              </a:ext>
            </a:extLst>
          </p:cNvPr>
          <p:cNvSpPr txBox="1"/>
          <p:nvPr/>
        </p:nvSpPr>
        <p:spPr>
          <a:xfrm>
            <a:off x="554182" y="5818910"/>
            <a:ext cx="114854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 file 8</a:t>
            </a:r>
            <a:r>
              <a:rPr lang="en-GB" dirty="0"/>
              <a:t>. Biomarker levels at baseline and at day 3-4 according to in-ICU outcome. Data are expressed as median (1</a:t>
            </a:r>
            <a:r>
              <a:rPr lang="en-GB" baseline="30000" dirty="0"/>
              <a:t>st</a:t>
            </a:r>
            <a:r>
              <a:rPr lang="en-GB" dirty="0"/>
              <a:t> IQR-3</a:t>
            </a:r>
            <a:r>
              <a:rPr lang="en-GB" baseline="30000" dirty="0"/>
              <a:t>rd</a:t>
            </a:r>
            <a:r>
              <a:rPr lang="en-GB" dirty="0"/>
              <a:t> IQR). a, survivors Day 0 vs Day 3-4; b non-survivors day 0 vs Day 3-4.</a:t>
            </a:r>
            <a:endParaRPr lang="fr-FR" dirty="0"/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52068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269</Words>
  <Application>Microsoft Office PowerPoint</Application>
  <PresentationFormat>Widescreen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2:00Z</dcterms:modified>
</cp:coreProperties>
</file>